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7" r:id="rId2"/>
  </p:sldIdLst>
  <p:sldSz cx="6119813" cy="80994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userDrawn="1">
          <p15:clr>
            <a:srgbClr val="A4A3A4"/>
          </p15:clr>
        </p15:guide>
        <p15:guide id="2" pos="204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BBDB3"/>
    <a:srgbClr val="FA4716"/>
    <a:srgbClr val="E3A5F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7" autoAdjust="0"/>
    <p:restoredTop sz="95677" autoAdjust="0"/>
  </p:normalViewPr>
  <p:slideViewPr>
    <p:cSldViewPr snapToGrid="0" showGuides="1">
      <p:cViewPr>
        <p:scale>
          <a:sx n="125" d="100"/>
          <a:sy n="125" d="100"/>
        </p:scale>
        <p:origin x="1160" y="40"/>
      </p:cViewPr>
      <p:guideLst>
        <p:guide orient="horz"/>
        <p:guide pos="204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ohh\OneDrive\&#12487;&#12473;&#12463;&#12488;&#12483;&#12503;\&#30740;&#31350;&#23460;\TC20cell%20count\20220214cellcount%20G2KD%20PA+LC\G2%20N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shohh\OneDrive\&#12487;&#12473;&#12463;&#12488;&#12483;&#12503;\&#30740;&#31350;&#23460;\TC20cell%20count\20220207cellcount%203BKD%20PA+LC\3B%20N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グラフ!$D$87</c:f>
              <c:strCache>
                <c:ptCount val="1"/>
                <c:pt idx="0">
                  <c:v>LC    0mM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グラフ!$K$103:$K$104,グラフ!$K$109:$K$110)</c:f>
                <c:numCache>
                  <c:formatCode>General</c:formatCode>
                  <c:ptCount val="4"/>
                  <c:pt idx="0">
                    <c:v>1.0779948155762964</c:v>
                  </c:pt>
                  <c:pt idx="1">
                    <c:v>0.51027913032646444</c:v>
                  </c:pt>
                  <c:pt idx="2">
                    <c:v>0.21466409889962854</c:v>
                  </c:pt>
                  <c:pt idx="3">
                    <c:v>0.14160490708978501</c:v>
                  </c:pt>
                </c:numCache>
                <c:extLst/>
              </c:numRef>
            </c:plus>
            <c:minus>
              <c:numRef>
                <c:f>(グラフ!$K$103:$K$104,グラフ!$K$109:$K$110)</c:f>
                <c:numCache>
                  <c:formatCode>General</c:formatCode>
                  <c:ptCount val="4"/>
                  <c:pt idx="0">
                    <c:v>1.0779948155762964</c:v>
                  </c:pt>
                  <c:pt idx="1">
                    <c:v>0.51027913032646444</c:v>
                  </c:pt>
                  <c:pt idx="2">
                    <c:v>0.21466409889962854</c:v>
                  </c:pt>
                  <c:pt idx="3">
                    <c:v>0.14160490708978501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1</c:v>
              </c:pt>
              <c:pt idx="1">
                <c:v>2</c:v>
              </c:pt>
              <c:pt idx="2">
                <c:v>7</c:v>
              </c:pt>
              <c:pt idx="3">
                <c:v>8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グラフ!$E$103:$E$104,グラフ!$E$109:$E$110)</c:f>
              <c:numCache>
                <c:formatCode>General</c:formatCode>
                <c:ptCount val="4"/>
                <c:pt idx="0">
                  <c:v>4.4432812005377968</c:v>
                </c:pt>
                <c:pt idx="1">
                  <c:v>1.9789989520677029</c:v>
                </c:pt>
                <c:pt idx="2">
                  <c:v>3.4339142411903887</c:v>
                </c:pt>
                <c:pt idx="3">
                  <c:v>1.8256978910504813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6A30-4CB7-BB65-1AD32F3B5090}"/>
            </c:ext>
          </c:extLst>
        </c:ser>
        <c:ser>
          <c:idx val="1"/>
          <c:order val="1"/>
          <c:tx>
            <c:strRef>
              <c:f>グラフ!$D$88</c:f>
              <c:strCache>
                <c:ptCount val="1"/>
                <c:pt idx="0">
                  <c:v>LC 0.5mM</c:v>
                </c:pt>
              </c:strCache>
            </c:strRef>
          </c:tx>
          <c:spPr>
            <a:solidFill>
              <a:schemeClr val="accent4">
                <a:lumMod val="40000"/>
                <a:lumOff val="6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グラフ!$L$103:$L$104,グラフ!$L$109:$L$110)</c:f>
                <c:numCache>
                  <c:formatCode>General</c:formatCode>
                  <c:ptCount val="4"/>
                  <c:pt idx="0">
                    <c:v>0.94486899173760452</c:v>
                  </c:pt>
                  <c:pt idx="1">
                    <c:v>0.55843753320159495</c:v>
                  </c:pt>
                  <c:pt idx="2">
                    <c:v>0.68951705009228936</c:v>
                  </c:pt>
                  <c:pt idx="3">
                    <c:v>0.406722052585682</c:v>
                  </c:pt>
                </c:numCache>
                <c:extLst/>
              </c:numRef>
            </c:plus>
            <c:minus>
              <c:numRef>
                <c:f>(グラフ!$L$103:$L$104,グラフ!$L$109:$L$110)</c:f>
                <c:numCache>
                  <c:formatCode>General</c:formatCode>
                  <c:ptCount val="4"/>
                  <c:pt idx="0">
                    <c:v>0.94486899173760452</c:v>
                  </c:pt>
                  <c:pt idx="1">
                    <c:v>0.55843753320159495</c:v>
                  </c:pt>
                  <c:pt idx="2">
                    <c:v>0.68951705009228936</c:v>
                  </c:pt>
                  <c:pt idx="3">
                    <c:v>0.406722052585682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1</c:v>
              </c:pt>
              <c:pt idx="1">
                <c:v>2</c:v>
              </c:pt>
              <c:pt idx="2">
                <c:v>7</c:v>
              </c:pt>
              <c:pt idx="3">
                <c:v>8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グラフ!$F$103:$F$104,グラフ!$F$109:$F$110)</c:f>
              <c:numCache>
                <c:formatCode>General</c:formatCode>
                <c:ptCount val="4"/>
                <c:pt idx="0">
                  <c:v>2.4732981248781933</c:v>
                </c:pt>
                <c:pt idx="1">
                  <c:v>0.81041437477081024</c:v>
                </c:pt>
                <c:pt idx="2">
                  <c:v>5.9891479023689271</c:v>
                </c:pt>
                <c:pt idx="3">
                  <c:v>1.659568741104545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6A30-4CB7-BB65-1AD32F3B5090}"/>
            </c:ext>
          </c:extLst>
        </c:ser>
        <c:ser>
          <c:idx val="2"/>
          <c:order val="2"/>
          <c:tx>
            <c:strRef>
              <c:f>グラフ!$D$89</c:f>
              <c:strCache>
                <c:ptCount val="1"/>
                <c:pt idx="0">
                  <c:v>LC    1mM</c:v>
                </c:pt>
              </c:strCache>
            </c:strRef>
          </c:tx>
          <c:spPr>
            <a:solidFill>
              <a:schemeClr val="accent4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グラフ!$M$103:$M$104,グラフ!$M$109:$M$110)</c:f>
                <c:numCache>
                  <c:formatCode>General</c:formatCode>
                  <c:ptCount val="4"/>
                  <c:pt idx="0">
                    <c:v>1.3922380376699168</c:v>
                  </c:pt>
                  <c:pt idx="1">
                    <c:v>0.51152781678584514</c:v>
                  </c:pt>
                  <c:pt idx="2">
                    <c:v>1.2198079223353273</c:v>
                  </c:pt>
                  <c:pt idx="3">
                    <c:v>0.50644760455230531</c:v>
                  </c:pt>
                </c:numCache>
                <c:extLst/>
              </c:numRef>
            </c:plus>
            <c:minus>
              <c:numRef>
                <c:f>(グラフ!$M$103:$M$104,グラフ!$M$109:$M$110)</c:f>
                <c:numCache>
                  <c:formatCode>General</c:formatCode>
                  <c:ptCount val="4"/>
                  <c:pt idx="0">
                    <c:v>1.3922380376699168</c:v>
                  </c:pt>
                  <c:pt idx="1">
                    <c:v>0.51152781678584514</c:v>
                  </c:pt>
                  <c:pt idx="2">
                    <c:v>1.2198079223353273</c:v>
                  </c:pt>
                  <c:pt idx="3">
                    <c:v>0.50644760455230531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1</c:v>
              </c:pt>
              <c:pt idx="1">
                <c:v>2</c:v>
              </c:pt>
              <c:pt idx="2">
                <c:v>7</c:v>
              </c:pt>
              <c:pt idx="3">
                <c:v>8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グラフ!$G$103:$G$104,グラフ!$G$109:$G$110)</c:f>
              <c:numCache>
                <c:formatCode>General</c:formatCode>
                <c:ptCount val="4"/>
                <c:pt idx="0">
                  <c:v>2.6534573471014085</c:v>
                </c:pt>
                <c:pt idx="1">
                  <c:v>1.8712912845520862</c:v>
                </c:pt>
                <c:pt idx="2">
                  <c:v>2.2189102216860541</c:v>
                </c:pt>
                <c:pt idx="3">
                  <c:v>0.87719298245614163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6A30-4CB7-BB65-1AD32F3B5090}"/>
            </c:ext>
          </c:extLst>
        </c:ser>
        <c:ser>
          <c:idx val="3"/>
          <c:order val="3"/>
          <c:tx>
            <c:strRef>
              <c:f>グラフ!$D$90</c:f>
              <c:strCache>
                <c:ptCount val="1"/>
                <c:pt idx="0">
                  <c:v>LC    2mM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グラフ!$N$103:$N$104,グラフ!$N$109:$N$110)</c:f>
                <c:numCache>
                  <c:formatCode>General</c:formatCode>
                  <c:ptCount val="4"/>
                  <c:pt idx="0">
                    <c:v>0.32237266279819238</c:v>
                  </c:pt>
                  <c:pt idx="1">
                    <c:v>0.22329352921098186</c:v>
                  </c:pt>
                  <c:pt idx="2">
                    <c:v>0.26951712344949691</c:v>
                  </c:pt>
                  <c:pt idx="3">
                    <c:v>0.28396905016311186</c:v>
                  </c:pt>
                </c:numCache>
                <c:extLst/>
              </c:numRef>
            </c:plus>
            <c:minus>
              <c:numRef>
                <c:f>(グラフ!$N$103:$N$104,グラフ!$N$109:$N$110)</c:f>
                <c:numCache>
                  <c:formatCode>General</c:formatCode>
                  <c:ptCount val="4"/>
                  <c:pt idx="0">
                    <c:v>0.32237266279819238</c:v>
                  </c:pt>
                  <c:pt idx="1">
                    <c:v>0.22329352921098186</c:v>
                  </c:pt>
                  <c:pt idx="2">
                    <c:v>0.26951712344949691</c:v>
                  </c:pt>
                  <c:pt idx="3">
                    <c:v>0.28396905016311186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1</c:v>
              </c:pt>
              <c:pt idx="1">
                <c:v>2</c:v>
              </c:pt>
              <c:pt idx="2">
                <c:v>7</c:v>
              </c:pt>
              <c:pt idx="3">
                <c:v>8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グラフ!$H$103:$H$104,グラフ!$H$109:$H$110)</c:f>
              <c:numCache>
                <c:formatCode>General</c:formatCode>
                <c:ptCount val="4"/>
                <c:pt idx="0">
                  <c:v>0.32237266279819227</c:v>
                </c:pt>
                <c:pt idx="1">
                  <c:v>0.44043213079219851</c:v>
                </c:pt>
                <c:pt idx="2">
                  <c:v>2.3724845009079587</c:v>
                </c:pt>
                <c:pt idx="3">
                  <c:v>1.4082657744070513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6A30-4CB7-BB65-1AD32F3B50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38158208"/>
        <c:axId val="838160704"/>
      </c:barChart>
      <c:catAx>
        <c:axId val="838158208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38160704"/>
        <c:crossesAt val="0"/>
        <c:auto val="1"/>
        <c:lblAlgn val="ctr"/>
        <c:lblOffset val="100"/>
        <c:noMultiLvlLbl val="0"/>
      </c:catAx>
      <c:valAx>
        <c:axId val="838160704"/>
        <c:scaling>
          <c:orientation val="minMax"/>
          <c:max val="35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38158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l"/>
      <c:legendEntry>
        <c:idx val="2"/>
        <c:txPr>
          <a:bodyPr rot="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</c:legendEntry>
      <c:layout>
        <c:manualLayout>
          <c:xMode val="edge"/>
          <c:yMode val="edge"/>
          <c:x val="0.14896516754850089"/>
          <c:y val="8.7264141414141419E-2"/>
          <c:w val="0.31465131350886971"/>
          <c:h val="0.25769898989898987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グラフ!$J$72</c:f>
              <c:strCache>
                <c:ptCount val="1"/>
                <c:pt idx="0">
                  <c:v>LC    0mM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グラフ!$K$103:$K$104,グラフ!$K$109:$K$110)</c:f>
                <c:numCache>
                  <c:formatCode>General</c:formatCode>
                  <c:ptCount val="4"/>
                  <c:pt idx="0">
                    <c:v>2.0141790737315279</c:v>
                  </c:pt>
                  <c:pt idx="1">
                    <c:v>0.47847703705737571</c:v>
                  </c:pt>
                  <c:pt idx="2">
                    <c:v>1.2069842185675417</c:v>
                  </c:pt>
                  <c:pt idx="3">
                    <c:v>0.73416702099745945</c:v>
                  </c:pt>
                </c:numCache>
                <c:extLst/>
              </c:numRef>
            </c:plus>
            <c:minus>
              <c:numRef>
                <c:f>(グラフ!$K$103:$K$104,グラフ!$K$109:$K$110)</c:f>
                <c:numCache>
                  <c:formatCode>General</c:formatCode>
                  <c:ptCount val="4"/>
                  <c:pt idx="0">
                    <c:v>2.0141790737315279</c:v>
                  </c:pt>
                  <c:pt idx="1">
                    <c:v>0.47847703705737571</c:v>
                  </c:pt>
                  <c:pt idx="2">
                    <c:v>1.2069842185675417</c:v>
                  </c:pt>
                  <c:pt idx="3">
                    <c:v>0.73416702099745945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1</c:v>
              </c:pt>
              <c:pt idx="1">
                <c:v>2</c:v>
              </c:pt>
              <c:pt idx="2">
                <c:v>7</c:v>
              </c:pt>
              <c:pt idx="3">
                <c:v>8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グラフ!$E$103:$E$104,グラフ!$E$109:$E$110)</c:f>
              <c:numCache>
                <c:formatCode>General</c:formatCode>
                <c:ptCount val="4"/>
                <c:pt idx="0">
                  <c:v>3.9025290345079213</c:v>
                </c:pt>
                <c:pt idx="1">
                  <c:v>0.95273355547328242</c:v>
                </c:pt>
                <c:pt idx="2">
                  <c:v>2.3454765646203413</c:v>
                </c:pt>
                <c:pt idx="3">
                  <c:v>1.388508226395027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0-5699-4C77-9778-3FDAED629419}"/>
            </c:ext>
          </c:extLst>
        </c:ser>
        <c:ser>
          <c:idx val="1"/>
          <c:order val="1"/>
          <c:tx>
            <c:strRef>
              <c:f>グラフ!$J$73</c:f>
              <c:strCache>
                <c:ptCount val="1"/>
                <c:pt idx="0">
                  <c:v>LC 0.5mM</c:v>
                </c:pt>
              </c:strCache>
            </c:strRef>
          </c:tx>
          <c:spPr>
            <a:solidFill>
              <a:schemeClr val="accent4">
                <a:lumMod val="40000"/>
                <a:lumOff val="60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グラフ!$L$103:$L$104,グラフ!$L$109:$L$110)</c:f>
                <c:numCache>
                  <c:formatCode>General</c:formatCode>
                  <c:ptCount val="4"/>
                  <c:pt idx="0">
                    <c:v>1.0000702770135683</c:v>
                  </c:pt>
                  <c:pt idx="1">
                    <c:v>1.0773524874481535</c:v>
                  </c:pt>
                  <c:pt idx="2">
                    <c:v>0.75001008106095679</c:v>
                  </c:pt>
                  <c:pt idx="3">
                    <c:v>0.78049816478246303</c:v>
                  </c:pt>
                </c:numCache>
                <c:extLst/>
              </c:numRef>
            </c:plus>
            <c:minus>
              <c:numRef>
                <c:f>(グラフ!$L$103:$L$104,グラフ!$L$109:$L$110)</c:f>
                <c:numCache>
                  <c:formatCode>General</c:formatCode>
                  <c:ptCount val="4"/>
                  <c:pt idx="0">
                    <c:v>1.0000702770135683</c:v>
                  </c:pt>
                  <c:pt idx="1">
                    <c:v>1.0773524874481535</c:v>
                  </c:pt>
                  <c:pt idx="2">
                    <c:v>0.75001008106095679</c:v>
                  </c:pt>
                  <c:pt idx="3">
                    <c:v>0.78049816478246303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1</c:v>
              </c:pt>
              <c:pt idx="1">
                <c:v>2</c:v>
              </c:pt>
              <c:pt idx="2">
                <c:v>7</c:v>
              </c:pt>
              <c:pt idx="3">
                <c:v>8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グラフ!$F$103:$F$104,グラフ!$F$109:$F$110)</c:f>
              <c:numCache>
                <c:formatCode>General</c:formatCode>
                <c:ptCount val="4"/>
                <c:pt idx="0">
                  <c:v>4.8893184958947797</c:v>
                </c:pt>
                <c:pt idx="1">
                  <c:v>2.3927786765799133</c:v>
                </c:pt>
                <c:pt idx="2">
                  <c:v>9.6686775339066457</c:v>
                </c:pt>
                <c:pt idx="3">
                  <c:v>2.2081529994829387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1-5699-4C77-9778-3FDAED629419}"/>
            </c:ext>
          </c:extLst>
        </c:ser>
        <c:ser>
          <c:idx val="2"/>
          <c:order val="2"/>
          <c:tx>
            <c:strRef>
              <c:f>グラフ!$J$74</c:f>
              <c:strCache>
                <c:ptCount val="1"/>
                <c:pt idx="0">
                  <c:v>LC    1mM</c:v>
                </c:pt>
              </c:strCache>
            </c:strRef>
          </c:tx>
          <c:spPr>
            <a:solidFill>
              <a:schemeClr val="accent4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グラフ!$M$103:$M$104,グラフ!$M$109:$M$110)</c:f>
                <c:numCache>
                  <c:formatCode>General</c:formatCode>
                  <c:ptCount val="4"/>
                  <c:pt idx="0">
                    <c:v>0.5253832677979855</c:v>
                  </c:pt>
                  <c:pt idx="1">
                    <c:v>0.69019522228139751</c:v>
                  </c:pt>
                  <c:pt idx="2">
                    <c:v>1.491362100692146</c:v>
                  </c:pt>
                  <c:pt idx="3">
                    <c:v>0.61281072668629422</c:v>
                  </c:pt>
                </c:numCache>
                <c:extLst/>
              </c:numRef>
            </c:plus>
            <c:minus>
              <c:numRef>
                <c:f>(グラフ!$M$103:$M$104,グラフ!$M$109:$M$110)</c:f>
                <c:numCache>
                  <c:formatCode>General</c:formatCode>
                  <c:ptCount val="4"/>
                  <c:pt idx="0">
                    <c:v>0.5253832677979855</c:v>
                  </c:pt>
                  <c:pt idx="1">
                    <c:v>0.69019522228139751</c:v>
                  </c:pt>
                  <c:pt idx="2">
                    <c:v>1.491362100692146</c:v>
                  </c:pt>
                  <c:pt idx="3">
                    <c:v>0.61281072668629422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1</c:v>
              </c:pt>
              <c:pt idx="1">
                <c:v>2</c:v>
              </c:pt>
              <c:pt idx="2">
                <c:v>7</c:v>
              </c:pt>
              <c:pt idx="3">
                <c:v>8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グラフ!$G$103:$G$104,グラフ!$G$109:$G$110)</c:f>
              <c:numCache>
                <c:formatCode>General</c:formatCode>
                <c:ptCount val="4"/>
                <c:pt idx="0">
                  <c:v>2.9575623399084208</c:v>
                </c:pt>
                <c:pt idx="1">
                  <c:v>3.3218177382169976</c:v>
                </c:pt>
                <c:pt idx="2">
                  <c:v>3.6931618379397122</c:v>
                </c:pt>
                <c:pt idx="3">
                  <c:v>1.1951719318195302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2-5699-4C77-9778-3FDAED629419}"/>
            </c:ext>
          </c:extLst>
        </c:ser>
        <c:ser>
          <c:idx val="3"/>
          <c:order val="3"/>
          <c:tx>
            <c:strRef>
              <c:f>グラフ!$J$75</c:f>
              <c:strCache>
                <c:ptCount val="1"/>
                <c:pt idx="0">
                  <c:v>LC    2mM</c:v>
                </c:pt>
              </c:strCache>
            </c:strRef>
          </c:tx>
          <c:spPr>
            <a:solidFill>
              <a:schemeClr val="accent4">
                <a:lumMod val="75000"/>
              </a:schemeClr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(グラフ!$N$103:$N$104,グラフ!$N$109:$N$110)</c:f>
                <c:numCache>
                  <c:formatCode>General</c:formatCode>
                  <c:ptCount val="4"/>
                  <c:pt idx="0">
                    <c:v>0.5253832677979855</c:v>
                  </c:pt>
                  <c:pt idx="1">
                    <c:v>0.8450672499668842</c:v>
                  </c:pt>
                  <c:pt idx="2">
                    <c:v>1.491362100692146</c:v>
                  </c:pt>
                  <c:pt idx="3">
                    <c:v>0.5807748704708019</c:v>
                  </c:pt>
                </c:numCache>
                <c:extLst/>
              </c:numRef>
            </c:plus>
            <c:minus>
              <c:numRef>
                <c:f>(グラフ!$N$103:$N$104,グラフ!$N$109:$N$110)</c:f>
                <c:numCache>
                  <c:formatCode>General</c:formatCode>
                  <c:ptCount val="4"/>
                  <c:pt idx="0">
                    <c:v>0.5253832677979855</c:v>
                  </c:pt>
                  <c:pt idx="1">
                    <c:v>0.8450672499668842</c:v>
                  </c:pt>
                  <c:pt idx="2">
                    <c:v>1.491362100692146</c:v>
                  </c:pt>
                  <c:pt idx="3">
                    <c:v>0.5807748704708019</c:v>
                  </c:pt>
                </c:numCache>
                <c:extLst/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Lit>
              <c:ptCount val="4"/>
              <c:pt idx="0">
                <c:v>1</c:v>
              </c:pt>
              <c:pt idx="1">
                <c:v>2</c:v>
              </c:pt>
              <c:pt idx="2">
                <c:v>7</c:v>
              </c:pt>
              <c:pt idx="3">
                <c:v>8</c:v>
              </c:pt>
              <c:extLst>
                <c:ext xmlns:c15="http://schemas.microsoft.com/office/drawing/2012/chart" uri="{02D57815-91ED-43cb-92C2-25804820EDAC}">
                  <c15:autoCat val="1"/>
                </c:ext>
              </c:extLst>
            </c:strLit>
          </c:cat>
          <c:val>
            <c:numRef>
              <c:f>(グラフ!$H$103:$H$104,グラフ!$H$109:$H$110)</c:f>
              <c:numCache>
                <c:formatCode>General</c:formatCode>
                <c:ptCount val="4"/>
                <c:pt idx="0">
                  <c:v>2.9575623399084208</c:v>
                </c:pt>
                <c:pt idx="1">
                  <c:v>5.7740506389478172</c:v>
                </c:pt>
                <c:pt idx="2">
                  <c:v>3.6931618379397122</c:v>
                </c:pt>
                <c:pt idx="3">
                  <c:v>1.6577007884556043</c:v>
                </c:pt>
              </c:numCache>
              <c:extLst/>
            </c:numRef>
          </c:val>
          <c:extLst>
            <c:ext xmlns:c16="http://schemas.microsoft.com/office/drawing/2014/chart" uri="{C3380CC4-5D6E-409C-BE32-E72D297353CC}">
              <c16:uniqueId val="{00000003-5699-4C77-9778-3FDAED62941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899722432"/>
        <c:axId val="899725344"/>
      </c:barChart>
      <c:catAx>
        <c:axId val="899722432"/>
        <c:scaling>
          <c:orientation val="minMax"/>
        </c:scaling>
        <c:delete val="0"/>
        <c:axPos val="b"/>
        <c:numFmt formatCode="General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899725344"/>
        <c:crosses val="autoZero"/>
        <c:auto val="1"/>
        <c:lblAlgn val="ctr"/>
        <c:lblOffset val="100"/>
        <c:noMultiLvlLbl val="0"/>
      </c:catAx>
      <c:valAx>
        <c:axId val="899725344"/>
        <c:scaling>
          <c:orientation val="minMax"/>
          <c:max val="35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89972243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l"/>
      <c:layout>
        <c:manualLayout>
          <c:xMode val="edge"/>
          <c:yMode val="edge"/>
          <c:x val="0.13918298059964726"/>
          <c:y val="0.11068383838383838"/>
          <c:w val="0.33251984126984124"/>
          <c:h val="0.25666868686868688"/>
        </c:manualLayout>
      </c:layout>
      <c:overlay val="1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25531"/>
            <a:ext cx="5201841" cy="2819800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254073"/>
            <a:ext cx="4589860" cy="1955486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5252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35302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31220"/>
            <a:ext cx="1319585" cy="686388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31220"/>
            <a:ext cx="3882256" cy="686388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034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27803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19234"/>
            <a:ext cx="5278339" cy="3369135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420242"/>
            <a:ext cx="5278339" cy="1771749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2946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156097"/>
            <a:ext cx="2600921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156097"/>
            <a:ext cx="2600921" cy="5139011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84673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31221"/>
            <a:ext cx="5278339" cy="156551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1985485"/>
            <a:ext cx="2588967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2958540"/>
            <a:ext cx="2588967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1985485"/>
            <a:ext cx="2601718" cy="973055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2958540"/>
            <a:ext cx="2601718" cy="435156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09852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4171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84723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66169"/>
            <a:ext cx="3098155" cy="575584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694021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39962"/>
            <a:ext cx="1973799" cy="1889866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66169"/>
            <a:ext cx="3098155" cy="575584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29828"/>
            <a:ext cx="1973799" cy="4501556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190971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31221"/>
            <a:ext cx="5278339" cy="156551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156097"/>
            <a:ext cx="5278339" cy="51390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6E101D-D717-4B0B-9089-381A62FB4F0A}" type="datetimeFigureOut">
              <a:rPr kumimoji="1" lang="ja-JP" altLang="en-US" smtClean="0"/>
              <a:t>2023/11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506969"/>
            <a:ext cx="2065437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506969"/>
            <a:ext cx="1376958" cy="4312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C8854-5702-42ED-916B-684D85FA2B6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044221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kumimoji="1"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kumimoji="1"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kumimoji="1"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8" name="グラフ 177">
            <a:extLst>
              <a:ext uri="{FF2B5EF4-FFF2-40B4-BE49-F238E27FC236}">
                <a16:creationId xmlns:a16="http://schemas.microsoft.com/office/drawing/2014/main" id="{1A6F3CBC-E6CE-C12B-CDA3-CDC69C96E1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6653124"/>
              </p:ext>
            </p:extLst>
          </p:nvPr>
        </p:nvGraphicFramePr>
        <p:xfrm>
          <a:off x="377051" y="601472"/>
          <a:ext cx="2268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24" name="グラフ 223">
            <a:extLst>
              <a:ext uri="{FF2B5EF4-FFF2-40B4-BE49-F238E27FC236}">
                <a16:creationId xmlns:a16="http://schemas.microsoft.com/office/drawing/2014/main" id="{373699B5-2745-62C3-992F-AC24547DF9A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8684486"/>
              </p:ext>
            </p:extLst>
          </p:nvPr>
        </p:nvGraphicFramePr>
        <p:xfrm>
          <a:off x="2562997" y="595947"/>
          <a:ext cx="2268000" cy="19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179" name="グループ化 178">
            <a:extLst>
              <a:ext uri="{FF2B5EF4-FFF2-40B4-BE49-F238E27FC236}">
                <a16:creationId xmlns:a16="http://schemas.microsoft.com/office/drawing/2014/main" id="{C802B413-90E8-FAFE-A897-5E2ECFF3902D}"/>
              </a:ext>
            </a:extLst>
          </p:cNvPr>
          <p:cNvGrpSpPr/>
          <p:nvPr/>
        </p:nvGrpSpPr>
        <p:grpSpPr>
          <a:xfrm>
            <a:off x="377056" y="2294255"/>
            <a:ext cx="2045096" cy="560882"/>
            <a:chOff x="334214" y="1746750"/>
            <a:chExt cx="2045096" cy="560882"/>
          </a:xfrm>
        </p:grpSpPr>
        <p:sp>
          <p:nvSpPr>
            <p:cNvPr id="180" name="テキスト ボックス 179">
              <a:extLst>
                <a:ext uri="{FF2B5EF4-FFF2-40B4-BE49-F238E27FC236}">
                  <a16:creationId xmlns:a16="http://schemas.microsoft.com/office/drawing/2014/main" id="{BE0D5F3D-D7C7-A7FC-DAB6-4A82B1CDA762}"/>
                </a:ext>
              </a:extLst>
            </p:cNvPr>
            <p:cNvSpPr txBox="1"/>
            <p:nvPr/>
          </p:nvSpPr>
          <p:spPr>
            <a:xfrm>
              <a:off x="334214" y="1917703"/>
              <a:ext cx="4657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PA</a:t>
              </a:r>
            </a:p>
          </p:txBody>
        </p:sp>
        <p:cxnSp>
          <p:nvCxnSpPr>
            <p:cNvPr id="181" name="直線コネクタ 180">
              <a:extLst>
                <a:ext uri="{FF2B5EF4-FFF2-40B4-BE49-F238E27FC236}">
                  <a16:creationId xmlns:a16="http://schemas.microsoft.com/office/drawing/2014/main" id="{714AA81F-40AB-681E-92E4-5977F4C86AE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9177" y="2096343"/>
              <a:ext cx="1717567" cy="0"/>
            </a:xfrm>
            <a:prstGeom prst="line">
              <a:avLst/>
            </a:prstGeom>
            <a:ln w="952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grpSp>
          <p:nvGrpSpPr>
            <p:cNvPr id="182" name="グループ化 181">
              <a:extLst>
                <a:ext uri="{FF2B5EF4-FFF2-40B4-BE49-F238E27FC236}">
                  <a16:creationId xmlns:a16="http://schemas.microsoft.com/office/drawing/2014/main" id="{93E958D4-FF2E-FDFB-801F-07754188D32C}"/>
                </a:ext>
              </a:extLst>
            </p:cNvPr>
            <p:cNvGrpSpPr/>
            <p:nvPr/>
          </p:nvGrpSpPr>
          <p:grpSpPr>
            <a:xfrm>
              <a:off x="631240" y="1746750"/>
              <a:ext cx="817926" cy="371009"/>
              <a:chOff x="631240" y="1760860"/>
              <a:chExt cx="817926" cy="371009"/>
            </a:xfrm>
          </p:grpSpPr>
          <p:cxnSp>
            <p:nvCxnSpPr>
              <p:cNvPr id="193" name="直線コネクタ 192">
                <a:extLst>
                  <a:ext uri="{FF2B5EF4-FFF2-40B4-BE49-F238E27FC236}">
                    <a16:creationId xmlns:a16="http://schemas.microsoft.com/office/drawing/2014/main" id="{2F912DB0-C382-AA2A-FAEA-01C90599531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31240" y="1942196"/>
                <a:ext cx="813133" cy="0"/>
              </a:xfrm>
              <a:prstGeom prst="line">
                <a:avLst/>
              </a:prstGeom>
              <a:ln w="9525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94" name="テキスト ボックス 193">
                <a:extLst>
                  <a:ext uri="{FF2B5EF4-FFF2-40B4-BE49-F238E27FC236}">
                    <a16:creationId xmlns:a16="http://schemas.microsoft.com/office/drawing/2014/main" id="{D0237DD6-B6EA-BFB4-50CC-E006B1B85666}"/>
                  </a:ext>
                </a:extLst>
              </p:cNvPr>
              <p:cNvSpPr txBox="1"/>
              <p:nvPr/>
            </p:nvSpPr>
            <p:spPr>
              <a:xfrm>
                <a:off x="876936" y="1931814"/>
                <a:ext cx="28710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95" name="グループ化 194">
                <a:extLst>
                  <a:ext uri="{FF2B5EF4-FFF2-40B4-BE49-F238E27FC236}">
                    <a16:creationId xmlns:a16="http://schemas.microsoft.com/office/drawing/2014/main" id="{D01D7370-155D-EF9A-3264-75A659FEC53D}"/>
                  </a:ext>
                </a:extLst>
              </p:cNvPr>
              <p:cNvGrpSpPr/>
              <p:nvPr/>
            </p:nvGrpSpPr>
            <p:grpSpPr>
              <a:xfrm>
                <a:off x="1112319" y="1765015"/>
                <a:ext cx="336847" cy="200055"/>
                <a:chOff x="673085" y="2413444"/>
                <a:chExt cx="336847" cy="200055"/>
              </a:xfrm>
            </p:grpSpPr>
            <p:sp>
              <p:nvSpPr>
                <p:cNvPr id="199" name="テキスト ボックス 198">
                  <a:extLst>
                    <a:ext uri="{FF2B5EF4-FFF2-40B4-BE49-F238E27FC236}">
                      <a16:creationId xmlns:a16="http://schemas.microsoft.com/office/drawing/2014/main" id="{F1182F18-3132-8043-517F-81E1CB554152}"/>
                    </a:ext>
                  </a:extLst>
                </p:cNvPr>
                <p:cNvSpPr txBox="1"/>
                <p:nvPr/>
              </p:nvSpPr>
              <p:spPr>
                <a:xfrm>
                  <a:off x="673085" y="2413444"/>
                  <a:ext cx="33684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D</a:t>
                  </a:r>
                  <a:endParaRPr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00" name="直線コネクタ 199">
                  <a:extLst>
                    <a:ext uri="{FF2B5EF4-FFF2-40B4-BE49-F238E27FC236}">
                      <a16:creationId xmlns:a16="http://schemas.microsoft.com/office/drawing/2014/main" id="{AB78BB34-35EF-0843-6A21-CE00B8DF763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73085" y="2452910"/>
                  <a:ext cx="327103" cy="0"/>
                </a:xfrm>
                <a:prstGeom prst="line">
                  <a:avLst/>
                </a:prstGeom>
                <a:ln w="9525"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96" name="グループ化 195">
                <a:extLst>
                  <a:ext uri="{FF2B5EF4-FFF2-40B4-BE49-F238E27FC236}">
                    <a16:creationId xmlns:a16="http://schemas.microsoft.com/office/drawing/2014/main" id="{4E1C2A14-31DF-0CAF-2155-DF872CAA1A48}"/>
                  </a:ext>
                </a:extLst>
              </p:cNvPr>
              <p:cNvGrpSpPr/>
              <p:nvPr/>
            </p:nvGrpSpPr>
            <p:grpSpPr>
              <a:xfrm>
                <a:off x="649177" y="1760860"/>
                <a:ext cx="336847" cy="200055"/>
                <a:chOff x="673085" y="2413444"/>
                <a:chExt cx="336847" cy="200055"/>
              </a:xfrm>
            </p:grpSpPr>
            <p:sp>
              <p:nvSpPr>
                <p:cNvPr id="197" name="テキスト ボックス 196">
                  <a:extLst>
                    <a:ext uri="{FF2B5EF4-FFF2-40B4-BE49-F238E27FC236}">
                      <a16:creationId xmlns:a16="http://schemas.microsoft.com/office/drawing/2014/main" id="{EC5CF2D3-E99D-C200-A202-14497F8A5E6D}"/>
                    </a:ext>
                  </a:extLst>
                </p:cNvPr>
                <p:cNvSpPr txBox="1"/>
                <p:nvPr/>
              </p:nvSpPr>
              <p:spPr>
                <a:xfrm>
                  <a:off x="673085" y="2413444"/>
                  <a:ext cx="33684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</a:t>
                  </a:r>
                  <a:endParaRPr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8" name="直線コネクタ 197">
                  <a:extLst>
                    <a:ext uri="{FF2B5EF4-FFF2-40B4-BE49-F238E27FC236}">
                      <a16:creationId xmlns:a16="http://schemas.microsoft.com/office/drawing/2014/main" id="{D90498EB-0A39-08C4-CAA9-30126D61D16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73085" y="2452910"/>
                  <a:ext cx="327103" cy="0"/>
                </a:xfrm>
                <a:prstGeom prst="line">
                  <a:avLst/>
                </a:prstGeom>
                <a:ln w="9525"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183" name="グループ化 182">
              <a:extLst>
                <a:ext uri="{FF2B5EF4-FFF2-40B4-BE49-F238E27FC236}">
                  <a16:creationId xmlns:a16="http://schemas.microsoft.com/office/drawing/2014/main" id="{B1E6E4F2-89CC-2AC4-6F06-97FA26A28DFC}"/>
                </a:ext>
              </a:extLst>
            </p:cNvPr>
            <p:cNvGrpSpPr/>
            <p:nvPr/>
          </p:nvGrpSpPr>
          <p:grpSpPr>
            <a:xfrm>
              <a:off x="1561384" y="1746750"/>
              <a:ext cx="817926" cy="369915"/>
              <a:chOff x="631240" y="1760860"/>
              <a:chExt cx="817926" cy="369915"/>
            </a:xfrm>
          </p:grpSpPr>
          <p:cxnSp>
            <p:nvCxnSpPr>
              <p:cNvPr id="185" name="直線コネクタ 184">
                <a:extLst>
                  <a:ext uri="{FF2B5EF4-FFF2-40B4-BE49-F238E27FC236}">
                    <a16:creationId xmlns:a16="http://schemas.microsoft.com/office/drawing/2014/main" id="{2868B659-2C1E-9C3F-C6F1-394775936BA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31240" y="1942196"/>
                <a:ext cx="813133" cy="0"/>
              </a:xfrm>
              <a:prstGeom prst="line">
                <a:avLst/>
              </a:prstGeom>
              <a:ln w="9525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86" name="テキスト ボックス 185">
                <a:extLst>
                  <a:ext uri="{FF2B5EF4-FFF2-40B4-BE49-F238E27FC236}">
                    <a16:creationId xmlns:a16="http://schemas.microsoft.com/office/drawing/2014/main" id="{AF3EACB3-9A7B-571A-0707-09F2EE81B362}"/>
                  </a:ext>
                </a:extLst>
              </p:cNvPr>
              <p:cNvSpPr txBox="1"/>
              <p:nvPr/>
            </p:nvSpPr>
            <p:spPr>
              <a:xfrm>
                <a:off x="858709" y="1930720"/>
                <a:ext cx="33684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87" name="グループ化 186">
                <a:extLst>
                  <a:ext uri="{FF2B5EF4-FFF2-40B4-BE49-F238E27FC236}">
                    <a16:creationId xmlns:a16="http://schemas.microsoft.com/office/drawing/2014/main" id="{0E47F6BD-21B1-CB7F-306B-02F3C596FB13}"/>
                  </a:ext>
                </a:extLst>
              </p:cNvPr>
              <p:cNvGrpSpPr/>
              <p:nvPr/>
            </p:nvGrpSpPr>
            <p:grpSpPr>
              <a:xfrm>
                <a:off x="1112319" y="1765015"/>
                <a:ext cx="336847" cy="200055"/>
                <a:chOff x="673085" y="2413444"/>
                <a:chExt cx="336847" cy="200055"/>
              </a:xfrm>
            </p:grpSpPr>
            <p:sp>
              <p:nvSpPr>
                <p:cNvPr id="191" name="テキスト ボックス 190">
                  <a:extLst>
                    <a:ext uri="{FF2B5EF4-FFF2-40B4-BE49-F238E27FC236}">
                      <a16:creationId xmlns:a16="http://schemas.microsoft.com/office/drawing/2014/main" id="{72F3454E-CD07-2E7F-ADF8-0A6CBB721B69}"/>
                    </a:ext>
                  </a:extLst>
                </p:cNvPr>
                <p:cNvSpPr txBox="1"/>
                <p:nvPr/>
              </p:nvSpPr>
              <p:spPr>
                <a:xfrm>
                  <a:off x="673085" y="2413444"/>
                  <a:ext cx="33684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D</a:t>
                  </a:r>
                  <a:endParaRPr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2" name="直線コネクタ 191">
                  <a:extLst>
                    <a:ext uri="{FF2B5EF4-FFF2-40B4-BE49-F238E27FC236}">
                      <a16:creationId xmlns:a16="http://schemas.microsoft.com/office/drawing/2014/main" id="{A7D455C2-ACFD-3D92-1331-1FF7A3999A9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73085" y="2452910"/>
                  <a:ext cx="327103" cy="0"/>
                </a:xfrm>
                <a:prstGeom prst="line">
                  <a:avLst/>
                </a:prstGeom>
                <a:ln w="9525"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8" name="グループ化 187">
                <a:extLst>
                  <a:ext uri="{FF2B5EF4-FFF2-40B4-BE49-F238E27FC236}">
                    <a16:creationId xmlns:a16="http://schemas.microsoft.com/office/drawing/2014/main" id="{6A27F48C-762B-42B1-7E59-2303E22A0D68}"/>
                  </a:ext>
                </a:extLst>
              </p:cNvPr>
              <p:cNvGrpSpPr/>
              <p:nvPr/>
            </p:nvGrpSpPr>
            <p:grpSpPr>
              <a:xfrm>
                <a:off x="649177" y="1760860"/>
                <a:ext cx="336847" cy="200055"/>
                <a:chOff x="673085" y="2413444"/>
                <a:chExt cx="336847" cy="200055"/>
              </a:xfrm>
            </p:grpSpPr>
            <p:sp>
              <p:nvSpPr>
                <p:cNvPr id="189" name="テキスト ボックス 188">
                  <a:extLst>
                    <a:ext uri="{FF2B5EF4-FFF2-40B4-BE49-F238E27FC236}">
                      <a16:creationId xmlns:a16="http://schemas.microsoft.com/office/drawing/2014/main" id="{7956769A-170D-235B-0FCE-684885A453E3}"/>
                    </a:ext>
                  </a:extLst>
                </p:cNvPr>
                <p:cNvSpPr txBox="1"/>
                <p:nvPr/>
              </p:nvSpPr>
              <p:spPr>
                <a:xfrm>
                  <a:off x="673085" y="2413444"/>
                  <a:ext cx="33684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</a:t>
                  </a:r>
                  <a:endParaRPr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90" name="直線コネクタ 189">
                  <a:extLst>
                    <a:ext uri="{FF2B5EF4-FFF2-40B4-BE49-F238E27FC236}">
                      <a16:creationId xmlns:a16="http://schemas.microsoft.com/office/drawing/2014/main" id="{3907AAAE-3BE6-106C-E58B-2EA313C28E0D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73085" y="2452910"/>
                  <a:ext cx="327103" cy="0"/>
                </a:xfrm>
                <a:prstGeom prst="line">
                  <a:avLst/>
                </a:prstGeom>
                <a:ln w="9525"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84" name="テキスト ボックス 183">
              <a:extLst>
                <a:ext uri="{FF2B5EF4-FFF2-40B4-BE49-F238E27FC236}">
                  <a16:creationId xmlns:a16="http://schemas.microsoft.com/office/drawing/2014/main" id="{90A7CFD2-E699-C062-9650-EA0A5FBF7434}"/>
                </a:ext>
              </a:extLst>
            </p:cNvPr>
            <p:cNvSpPr txBox="1"/>
            <p:nvPr/>
          </p:nvSpPr>
          <p:spPr>
            <a:xfrm>
              <a:off x="727038" y="2092188"/>
              <a:ext cx="156184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epG2 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ormoxia</a:t>
              </a:r>
              <a:endParaRPr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1" name="テキスト ボックス 200">
            <a:extLst>
              <a:ext uri="{FF2B5EF4-FFF2-40B4-BE49-F238E27FC236}">
                <a16:creationId xmlns:a16="http://schemas.microsoft.com/office/drawing/2014/main" id="{9DD0454A-FE22-978D-FE2D-3619F4176656}"/>
              </a:ext>
            </a:extLst>
          </p:cNvPr>
          <p:cNvSpPr txBox="1"/>
          <p:nvPr/>
        </p:nvSpPr>
        <p:spPr>
          <a:xfrm rot="16200000">
            <a:off x="-442305" y="1386763"/>
            <a:ext cx="1614929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kumimoji="1" lang="en-US" altLang="ja-JP" sz="700" b="1" dirty="0">
                <a:latin typeface="Arial" panose="020B0604020202020204" pitchFamily="34" charset="0"/>
                <a:cs typeface="Arial" panose="020B0604020202020204" pitchFamily="34" charset="0"/>
              </a:rPr>
              <a:t>Cell death rate (%)</a:t>
            </a:r>
            <a:endParaRPr lang="ja-JP" altLang="en-US" sz="7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2" name="グループ化 201">
            <a:extLst>
              <a:ext uri="{FF2B5EF4-FFF2-40B4-BE49-F238E27FC236}">
                <a16:creationId xmlns:a16="http://schemas.microsoft.com/office/drawing/2014/main" id="{7A033C3A-3B46-412D-1D3B-5F904A9C2165}"/>
              </a:ext>
            </a:extLst>
          </p:cNvPr>
          <p:cNvGrpSpPr/>
          <p:nvPr/>
        </p:nvGrpSpPr>
        <p:grpSpPr>
          <a:xfrm>
            <a:off x="2871883" y="2292565"/>
            <a:ext cx="1943143" cy="560882"/>
            <a:chOff x="631240" y="1746750"/>
            <a:chExt cx="1943143" cy="560882"/>
          </a:xfrm>
        </p:grpSpPr>
        <p:sp>
          <p:nvSpPr>
            <p:cNvPr id="203" name="テキスト ボックス 202">
              <a:extLst>
                <a:ext uri="{FF2B5EF4-FFF2-40B4-BE49-F238E27FC236}">
                  <a16:creationId xmlns:a16="http://schemas.microsoft.com/office/drawing/2014/main" id="{1A142E64-54F2-43F1-D215-E84E21342C3A}"/>
                </a:ext>
              </a:extLst>
            </p:cNvPr>
            <p:cNvSpPr txBox="1"/>
            <p:nvPr/>
          </p:nvSpPr>
          <p:spPr>
            <a:xfrm>
              <a:off x="2224588" y="1916795"/>
              <a:ext cx="349795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[</a:t>
              </a:r>
              <a:r>
                <a:rPr lang="en-US" altLang="ja-JP" sz="600" dirty="0" err="1">
                  <a:latin typeface="Arial" panose="020B0604020202020204" pitchFamily="34" charset="0"/>
                  <a:cs typeface="Arial" panose="020B0604020202020204" pitchFamily="34" charset="0"/>
                </a:rPr>
                <a:t>μM</a:t>
              </a:r>
              <a:r>
                <a:rPr lang="en-US" altLang="ja-JP" sz="600" dirty="0">
                  <a:latin typeface="Arial" panose="020B0604020202020204" pitchFamily="34" charset="0"/>
                  <a:cs typeface="Arial" panose="020B0604020202020204" pitchFamily="34" charset="0"/>
                </a:rPr>
                <a:t>]</a:t>
              </a:r>
              <a:endParaRPr lang="ja-JP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4" name="直線コネクタ 203">
              <a:extLst>
                <a:ext uri="{FF2B5EF4-FFF2-40B4-BE49-F238E27FC236}">
                  <a16:creationId xmlns:a16="http://schemas.microsoft.com/office/drawing/2014/main" id="{64ECE33F-84B5-F8FA-3B47-AFB29A42FE3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649177" y="2096343"/>
              <a:ext cx="1717567" cy="0"/>
            </a:xfrm>
            <a:prstGeom prst="line">
              <a:avLst/>
            </a:prstGeom>
            <a:ln w="9525"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grpSp>
          <p:nvGrpSpPr>
            <p:cNvPr id="205" name="グループ化 204">
              <a:extLst>
                <a:ext uri="{FF2B5EF4-FFF2-40B4-BE49-F238E27FC236}">
                  <a16:creationId xmlns:a16="http://schemas.microsoft.com/office/drawing/2014/main" id="{3905D30F-7C02-6B1E-2529-EAF3553FACD1}"/>
                </a:ext>
              </a:extLst>
            </p:cNvPr>
            <p:cNvGrpSpPr/>
            <p:nvPr/>
          </p:nvGrpSpPr>
          <p:grpSpPr>
            <a:xfrm>
              <a:off x="631240" y="1746750"/>
              <a:ext cx="817926" cy="371009"/>
              <a:chOff x="631240" y="1760860"/>
              <a:chExt cx="817926" cy="371009"/>
            </a:xfrm>
          </p:grpSpPr>
          <p:cxnSp>
            <p:nvCxnSpPr>
              <p:cNvPr id="216" name="直線コネクタ 215">
                <a:extLst>
                  <a:ext uri="{FF2B5EF4-FFF2-40B4-BE49-F238E27FC236}">
                    <a16:creationId xmlns:a16="http://schemas.microsoft.com/office/drawing/2014/main" id="{D600D895-F9C8-ECA0-6B79-E12E4149EA5A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31240" y="1942196"/>
                <a:ext cx="813133" cy="0"/>
              </a:xfrm>
              <a:prstGeom prst="line">
                <a:avLst/>
              </a:prstGeom>
              <a:ln w="9525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17" name="テキスト ボックス 216">
                <a:extLst>
                  <a:ext uri="{FF2B5EF4-FFF2-40B4-BE49-F238E27FC236}">
                    <a16:creationId xmlns:a16="http://schemas.microsoft.com/office/drawing/2014/main" id="{19B6979E-158E-B230-12AF-B072EBD2E798}"/>
                  </a:ext>
                </a:extLst>
              </p:cNvPr>
              <p:cNvSpPr txBox="1"/>
              <p:nvPr/>
            </p:nvSpPr>
            <p:spPr>
              <a:xfrm>
                <a:off x="876936" y="1931814"/>
                <a:ext cx="287106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18" name="グループ化 217">
                <a:extLst>
                  <a:ext uri="{FF2B5EF4-FFF2-40B4-BE49-F238E27FC236}">
                    <a16:creationId xmlns:a16="http://schemas.microsoft.com/office/drawing/2014/main" id="{BFD3D592-BD20-0C4D-5FF1-F13F867876BC}"/>
                  </a:ext>
                </a:extLst>
              </p:cNvPr>
              <p:cNvGrpSpPr/>
              <p:nvPr/>
            </p:nvGrpSpPr>
            <p:grpSpPr>
              <a:xfrm>
                <a:off x="1112319" y="1765015"/>
                <a:ext cx="336847" cy="200055"/>
                <a:chOff x="673085" y="2413444"/>
                <a:chExt cx="336847" cy="200055"/>
              </a:xfrm>
            </p:grpSpPr>
            <p:sp>
              <p:nvSpPr>
                <p:cNvPr id="222" name="テキスト ボックス 221">
                  <a:extLst>
                    <a:ext uri="{FF2B5EF4-FFF2-40B4-BE49-F238E27FC236}">
                      <a16:creationId xmlns:a16="http://schemas.microsoft.com/office/drawing/2014/main" id="{F556B887-8BD5-CDA8-F298-33C61AAC3E29}"/>
                    </a:ext>
                  </a:extLst>
                </p:cNvPr>
                <p:cNvSpPr txBox="1"/>
                <p:nvPr/>
              </p:nvSpPr>
              <p:spPr>
                <a:xfrm>
                  <a:off x="673085" y="2413444"/>
                  <a:ext cx="33684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D</a:t>
                  </a:r>
                  <a:endParaRPr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23" name="直線コネクタ 222">
                  <a:extLst>
                    <a:ext uri="{FF2B5EF4-FFF2-40B4-BE49-F238E27FC236}">
                      <a16:creationId xmlns:a16="http://schemas.microsoft.com/office/drawing/2014/main" id="{10178D95-EC3E-2BA3-7D4E-1BDD6698CF7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73085" y="2452910"/>
                  <a:ext cx="327103" cy="0"/>
                </a:xfrm>
                <a:prstGeom prst="line">
                  <a:avLst/>
                </a:prstGeom>
                <a:ln w="9525"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9" name="グループ化 218">
                <a:extLst>
                  <a:ext uri="{FF2B5EF4-FFF2-40B4-BE49-F238E27FC236}">
                    <a16:creationId xmlns:a16="http://schemas.microsoft.com/office/drawing/2014/main" id="{9D0B1ED3-974D-F2FA-07D3-F8CE32EFCAED}"/>
                  </a:ext>
                </a:extLst>
              </p:cNvPr>
              <p:cNvGrpSpPr/>
              <p:nvPr/>
            </p:nvGrpSpPr>
            <p:grpSpPr>
              <a:xfrm>
                <a:off x="649177" y="1760860"/>
                <a:ext cx="336847" cy="200055"/>
                <a:chOff x="673085" y="2413444"/>
                <a:chExt cx="336847" cy="200055"/>
              </a:xfrm>
            </p:grpSpPr>
            <p:sp>
              <p:nvSpPr>
                <p:cNvPr id="220" name="テキスト ボックス 219">
                  <a:extLst>
                    <a:ext uri="{FF2B5EF4-FFF2-40B4-BE49-F238E27FC236}">
                      <a16:creationId xmlns:a16="http://schemas.microsoft.com/office/drawing/2014/main" id="{BB88C8E2-52BF-6C4F-2927-FA0FAE2E57BA}"/>
                    </a:ext>
                  </a:extLst>
                </p:cNvPr>
                <p:cNvSpPr txBox="1"/>
                <p:nvPr/>
              </p:nvSpPr>
              <p:spPr>
                <a:xfrm>
                  <a:off x="673085" y="2413444"/>
                  <a:ext cx="33684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</a:t>
                  </a:r>
                  <a:endParaRPr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21" name="直線コネクタ 220">
                  <a:extLst>
                    <a:ext uri="{FF2B5EF4-FFF2-40B4-BE49-F238E27FC236}">
                      <a16:creationId xmlns:a16="http://schemas.microsoft.com/office/drawing/2014/main" id="{BA7F1B6C-090F-55E5-9513-69DDC388664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73085" y="2452910"/>
                  <a:ext cx="327103" cy="0"/>
                </a:xfrm>
                <a:prstGeom prst="line">
                  <a:avLst/>
                </a:prstGeom>
                <a:ln w="9525"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206" name="グループ化 205">
              <a:extLst>
                <a:ext uri="{FF2B5EF4-FFF2-40B4-BE49-F238E27FC236}">
                  <a16:creationId xmlns:a16="http://schemas.microsoft.com/office/drawing/2014/main" id="{35DA5797-8CAB-12D1-1618-66DD930A458C}"/>
                </a:ext>
              </a:extLst>
            </p:cNvPr>
            <p:cNvGrpSpPr/>
            <p:nvPr/>
          </p:nvGrpSpPr>
          <p:grpSpPr>
            <a:xfrm>
              <a:off x="1561384" y="1746750"/>
              <a:ext cx="817926" cy="369915"/>
              <a:chOff x="631240" y="1760860"/>
              <a:chExt cx="817926" cy="369915"/>
            </a:xfrm>
          </p:grpSpPr>
          <p:cxnSp>
            <p:nvCxnSpPr>
              <p:cNvPr id="208" name="直線コネクタ 207">
                <a:extLst>
                  <a:ext uri="{FF2B5EF4-FFF2-40B4-BE49-F238E27FC236}">
                    <a16:creationId xmlns:a16="http://schemas.microsoft.com/office/drawing/2014/main" id="{22020105-E9C0-AA78-3AF4-18CE2D5CCC9E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631240" y="1942196"/>
                <a:ext cx="813133" cy="0"/>
              </a:xfrm>
              <a:prstGeom prst="line">
                <a:avLst/>
              </a:prstGeom>
              <a:ln w="9525"/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09" name="テキスト ボックス 208">
                <a:extLst>
                  <a:ext uri="{FF2B5EF4-FFF2-40B4-BE49-F238E27FC236}">
                    <a16:creationId xmlns:a16="http://schemas.microsoft.com/office/drawing/2014/main" id="{FCE80029-976D-0A93-5BE8-871B68B048D7}"/>
                  </a:ext>
                </a:extLst>
              </p:cNvPr>
              <p:cNvSpPr txBox="1"/>
              <p:nvPr/>
            </p:nvSpPr>
            <p:spPr>
              <a:xfrm>
                <a:off x="858709" y="1930720"/>
                <a:ext cx="336847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ja-JP" sz="7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ja-JP" altLang="en-US" sz="7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210" name="グループ化 209">
                <a:extLst>
                  <a:ext uri="{FF2B5EF4-FFF2-40B4-BE49-F238E27FC236}">
                    <a16:creationId xmlns:a16="http://schemas.microsoft.com/office/drawing/2014/main" id="{8EE7E089-218B-8F67-C744-18CC74513162}"/>
                  </a:ext>
                </a:extLst>
              </p:cNvPr>
              <p:cNvGrpSpPr/>
              <p:nvPr/>
            </p:nvGrpSpPr>
            <p:grpSpPr>
              <a:xfrm>
                <a:off x="1112319" y="1765015"/>
                <a:ext cx="336847" cy="200055"/>
                <a:chOff x="673085" y="2413444"/>
                <a:chExt cx="336847" cy="200055"/>
              </a:xfrm>
            </p:grpSpPr>
            <p:sp>
              <p:nvSpPr>
                <p:cNvPr id="214" name="テキスト ボックス 213">
                  <a:extLst>
                    <a:ext uri="{FF2B5EF4-FFF2-40B4-BE49-F238E27FC236}">
                      <a16:creationId xmlns:a16="http://schemas.microsoft.com/office/drawing/2014/main" id="{D15C00C1-846C-B03E-22D7-E96B87AFC8CD}"/>
                    </a:ext>
                  </a:extLst>
                </p:cNvPr>
                <p:cNvSpPr txBox="1"/>
                <p:nvPr/>
              </p:nvSpPr>
              <p:spPr>
                <a:xfrm>
                  <a:off x="673085" y="2413444"/>
                  <a:ext cx="33684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D</a:t>
                  </a:r>
                  <a:endParaRPr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15" name="直線コネクタ 214">
                  <a:extLst>
                    <a:ext uri="{FF2B5EF4-FFF2-40B4-BE49-F238E27FC236}">
                      <a16:creationId xmlns:a16="http://schemas.microsoft.com/office/drawing/2014/main" id="{A830707E-21A4-8106-3FE9-FA96FC09412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73085" y="2452910"/>
                  <a:ext cx="327103" cy="0"/>
                </a:xfrm>
                <a:prstGeom prst="line">
                  <a:avLst/>
                </a:prstGeom>
                <a:ln w="9525"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11" name="グループ化 210">
                <a:extLst>
                  <a:ext uri="{FF2B5EF4-FFF2-40B4-BE49-F238E27FC236}">
                    <a16:creationId xmlns:a16="http://schemas.microsoft.com/office/drawing/2014/main" id="{4E10A96E-6C2C-D290-5FA6-F739DF312F1E}"/>
                  </a:ext>
                </a:extLst>
              </p:cNvPr>
              <p:cNvGrpSpPr/>
              <p:nvPr/>
            </p:nvGrpSpPr>
            <p:grpSpPr>
              <a:xfrm>
                <a:off x="649177" y="1760860"/>
                <a:ext cx="336847" cy="200055"/>
                <a:chOff x="673085" y="2413444"/>
                <a:chExt cx="336847" cy="200055"/>
              </a:xfrm>
            </p:grpSpPr>
            <p:sp>
              <p:nvSpPr>
                <p:cNvPr id="212" name="テキスト ボックス 211">
                  <a:extLst>
                    <a:ext uri="{FF2B5EF4-FFF2-40B4-BE49-F238E27FC236}">
                      <a16:creationId xmlns:a16="http://schemas.microsoft.com/office/drawing/2014/main" id="{B4BC076B-8539-40D1-0333-AE6F1BAD2996}"/>
                    </a:ext>
                  </a:extLst>
                </p:cNvPr>
                <p:cNvSpPr txBox="1"/>
                <p:nvPr/>
              </p:nvSpPr>
              <p:spPr>
                <a:xfrm>
                  <a:off x="673085" y="2413444"/>
                  <a:ext cx="336847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ja-JP" sz="7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SC</a:t>
                  </a:r>
                  <a:endParaRPr lang="ja-JP" altLang="en-US" sz="7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13" name="直線コネクタ 212">
                  <a:extLst>
                    <a:ext uri="{FF2B5EF4-FFF2-40B4-BE49-F238E27FC236}">
                      <a16:creationId xmlns:a16="http://schemas.microsoft.com/office/drawing/2014/main" id="{2E0E67B8-BAAB-166F-EB90-E123F16D885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H="1">
                  <a:off x="673085" y="2452910"/>
                  <a:ext cx="327103" cy="0"/>
                </a:xfrm>
                <a:prstGeom prst="line">
                  <a:avLst/>
                </a:prstGeom>
                <a:ln w="9525"/>
              </p:spPr>
              <p:style>
                <a:lnRef idx="3">
                  <a:schemeClr val="dk1"/>
                </a:lnRef>
                <a:fillRef idx="0">
                  <a:schemeClr val="dk1"/>
                </a:fillRef>
                <a:effectRef idx="2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07" name="テキスト ボックス 206">
              <a:extLst>
                <a:ext uri="{FF2B5EF4-FFF2-40B4-BE49-F238E27FC236}">
                  <a16:creationId xmlns:a16="http://schemas.microsoft.com/office/drawing/2014/main" id="{125C7BE6-E086-AC99-45D7-511B3E8D1EC9}"/>
                </a:ext>
              </a:extLst>
            </p:cNvPr>
            <p:cNvSpPr txBox="1"/>
            <p:nvPr/>
          </p:nvSpPr>
          <p:spPr>
            <a:xfrm>
              <a:off x="727038" y="2092188"/>
              <a:ext cx="156184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kumimoji="1" lang="en-US" altLang="ja-JP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Hep3B </a:t>
              </a:r>
              <a:r>
                <a:rPr kumimoji="1" lang="en-US" altLang="ja-JP" sz="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ormoxia</a:t>
              </a:r>
              <a:endParaRPr lang="ja-JP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6" name="左大かっこ 225">
            <a:extLst>
              <a:ext uri="{FF2B5EF4-FFF2-40B4-BE49-F238E27FC236}">
                <a16:creationId xmlns:a16="http://schemas.microsoft.com/office/drawing/2014/main" id="{BFDB3CF9-7B4C-0D18-B445-F792F79368FA}"/>
              </a:ext>
            </a:extLst>
          </p:cNvPr>
          <p:cNvSpPr/>
          <p:nvPr/>
        </p:nvSpPr>
        <p:spPr>
          <a:xfrm rot="5400000">
            <a:off x="847575" y="1813751"/>
            <a:ext cx="29191" cy="256822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テキスト ボックス 226">
            <a:extLst>
              <a:ext uri="{FF2B5EF4-FFF2-40B4-BE49-F238E27FC236}">
                <a16:creationId xmlns:a16="http://schemas.microsoft.com/office/drawing/2014/main" id="{8333EF12-7ADC-CBF0-FF12-80CB5CC80A8B}"/>
              </a:ext>
            </a:extLst>
          </p:cNvPr>
          <p:cNvSpPr txBox="1"/>
          <p:nvPr/>
        </p:nvSpPr>
        <p:spPr>
          <a:xfrm>
            <a:off x="733759" y="1786287"/>
            <a:ext cx="29949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2" name="左大かっこ 231">
            <a:extLst>
              <a:ext uri="{FF2B5EF4-FFF2-40B4-BE49-F238E27FC236}">
                <a16:creationId xmlns:a16="http://schemas.microsoft.com/office/drawing/2014/main" id="{CB52E085-AA7A-2C68-D1D5-A3781C1C2839}"/>
              </a:ext>
            </a:extLst>
          </p:cNvPr>
          <p:cNvSpPr/>
          <p:nvPr/>
        </p:nvSpPr>
        <p:spPr>
          <a:xfrm rot="5400000">
            <a:off x="1693821" y="1864448"/>
            <a:ext cx="34350" cy="107048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テキスト ボックス 232">
            <a:extLst>
              <a:ext uri="{FF2B5EF4-FFF2-40B4-BE49-F238E27FC236}">
                <a16:creationId xmlns:a16="http://schemas.microsoft.com/office/drawing/2014/main" id="{29A1E1A7-ED4E-7667-184C-A596795627F3}"/>
              </a:ext>
            </a:extLst>
          </p:cNvPr>
          <p:cNvSpPr txBox="1"/>
          <p:nvPr/>
        </p:nvSpPr>
        <p:spPr>
          <a:xfrm>
            <a:off x="1605926" y="1760887"/>
            <a:ext cx="1495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左大かっこ 235">
            <a:extLst>
              <a:ext uri="{FF2B5EF4-FFF2-40B4-BE49-F238E27FC236}">
                <a16:creationId xmlns:a16="http://schemas.microsoft.com/office/drawing/2014/main" id="{94A5E845-7384-A987-359E-00BA9E7E7598}"/>
              </a:ext>
            </a:extLst>
          </p:cNvPr>
          <p:cNvSpPr/>
          <p:nvPr/>
        </p:nvSpPr>
        <p:spPr>
          <a:xfrm rot="5400000">
            <a:off x="3889613" y="1715588"/>
            <a:ext cx="34350" cy="107048"/>
          </a:xfrm>
          <a:prstGeom prst="leftBracket">
            <a:avLst>
              <a:gd name="adj" fmla="val 0"/>
            </a:avLst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ja-JP" altLang="en-US" sz="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テキスト ボックス 236">
            <a:extLst>
              <a:ext uri="{FF2B5EF4-FFF2-40B4-BE49-F238E27FC236}">
                <a16:creationId xmlns:a16="http://schemas.microsoft.com/office/drawing/2014/main" id="{427467FF-5981-1AFF-828F-948A8D92A0CD}"/>
              </a:ext>
            </a:extLst>
          </p:cNvPr>
          <p:cNvSpPr txBox="1"/>
          <p:nvPr/>
        </p:nvSpPr>
        <p:spPr>
          <a:xfrm>
            <a:off x="3801718" y="1612027"/>
            <a:ext cx="14952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ja-JP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9959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996</TotalTime>
  <Words>27</Words>
  <Application>Microsoft Office PowerPoint</Application>
  <PresentationFormat>ユーザー設定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松藤 祥平</dc:creator>
  <cp:lastModifiedBy>祥平 松藤</cp:lastModifiedBy>
  <cp:revision>59</cp:revision>
  <dcterms:created xsi:type="dcterms:W3CDTF">2023-08-18T02:19:21Z</dcterms:created>
  <dcterms:modified xsi:type="dcterms:W3CDTF">2023-11-09T08:40:28Z</dcterms:modified>
</cp:coreProperties>
</file>